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397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1429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2325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1029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4087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2920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0542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9467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6228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1890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2017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8856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98001-8B6B-46FE-9670-8EC8FAAA233F}" type="datetimeFigureOut">
              <a:rPr lang="en-US" smtClean="0"/>
              <a:t>3/28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C351F6-57E3-4A20-B24D-A4C65EB62C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7681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867" y="592670"/>
            <a:ext cx="3657600" cy="2743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59867" y="626536"/>
            <a:ext cx="3657600" cy="27432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95867" y="3843866"/>
            <a:ext cx="3657600" cy="27432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59867" y="3843866"/>
            <a:ext cx="3657600" cy="27432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981200" y="223338"/>
            <a:ext cx="1275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Bright field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31463" y="257204"/>
            <a:ext cx="72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srgbClr val="0000FF"/>
                </a:solidFill>
                <a:latin typeface="Arial"/>
                <a:cs typeface="Arial"/>
              </a:rPr>
              <a:t>DAPI</a:t>
            </a:r>
            <a:endParaRPr 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969526" y="3474534"/>
            <a:ext cx="1185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srgbClr val="008000"/>
                </a:solidFill>
                <a:latin typeface="Arial"/>
                <a:cs typeface="Arial"/>
              </a:rPr>
              <a:t>Phalloidin</a:t>
            </a:r>
            <a:endParaRPr lang="en-US" dirty="0">
              <a:solidFill>
                <a:srgbClr val="008000"/>
              </a:solidFill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43600" y="3474538"/>
            <a:ext cx="1788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srgbClr val="008000"/>
                </a:solidFill>
                <a:latin typeface="Arial"/>
                <a:cs typeface="Arial"/>
              </a:rPr>
              <a:t>Phalloidin</a:t>
            </a:r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/</a:t>
            </a:r>
            <a:r>
              <a:rPr lang="en-US" dirty="0">
                <a:solidFill>
                  <a:srgbClr val="0000FF"/>
                </a:solidFill>
                <a:latin typeface="Arial"/>
                <a:cs typeface="Arial"/>
              </a:rPr>
              <a:t>DAPI</a:t>
            </a:r>
            <a:endParaRPr 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8237" y="7253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Figure 4A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671135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examethasone.jpg"/>
          <p:cNvPicPr preferRelativeResize="0"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004642" y="3773650"/>
            <a:ext cx="2743200" cy="2743200"/>
          </a:xfrm>
          <a:prstGeom prst="rect">
            <a:avLst/>
          </a:prstGeom>
        </p:spPr>
      </p:pic>
      <p:pic>
        <p:nvPicPr>
          <p:cNvPr id="5" name="Picture 4" descr="G1C_Control.JPG"/>
          <p:cNvPicPr preferRelativeResize="0"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86518" y="3773650"/>
            <a:ext cx="2743200" cy="2743200"/>
          </a:xfrm>
          <a:prstGeom prst="rect">
            <a:avLst/>
          </a:prstGeom>
        </p:spPr>
      </p:pic>
      <p:pic>
        <p:nvPicPr>
          <p:cNvPr id="6" name="Picture 5" descr="D1 multipotent 007.jpg"/>
          <p:cNvPicPr preferRelativeResize="0"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586518" y="480806"/>
            <a:ext cx="2743200" cy="2743200"/>
          </a:xfrm>
          <a:prstGeom prst="rect">
            <a:avLst/>
          </a:prstGeom>
        </p:spPr>
      </p:pic>
      <p:pic>
        <p:nvPicPr>
          <p:cNvPr id="7" name="Picture 6" descr="D1 multipotent 009.jpg"/>
          <p:cNvPicPr preferRelativeResize="0"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5004642" y="480806"/>
            <a:ext cx="2743200" cy="27432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641600" y="8787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BM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41600" y="340431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BM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34000" y="111474"/>
            <a:ext cx="2237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Osteogenic medium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69677" y="3404318"/>
            <a:ext cx="2996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BM+10</a:t>
            </a:r>
            <a:r>
              <a:rPr lang="en-US" baseline="30000" dirty="0">
                <a:solidFill>
                  <a:prstClr val="black"/>
                </a:solidFill>
                <a:latin typeface="Arial"/>
                <a:cs typeface="Arial"/>
              </a:rPr>
              <a:t>-7</a:t>
            </a:r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M Dexamethasone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8237" y="72538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dirty="0">
                <a:solidFill>
                  <a:prstClr val="black"/>
                </a:solidFill>
                <a:latin typeface="Arial"/>
                <a:cs typeface="Arial"/>
              </a:rPr>
              <a:t>Figure 4B</a:t>
            </a:r>
            <a:endParaRPr lang="en-US" dirty="0">
              <a:solidFill>
                <a:prstClr val="black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3621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5</Words>
  <Application>Microsoft Office PowerPoint</Application>
  <PresentationFormat>On-screen Show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jit S. Dighe</dc:creator>
  <cp:lastModifiedBy>Abhijit S. Dighe</cp:lastModifiedBy>
  <cp:revision>1</cp:revision>
  <dcterms:created xsi:type="dcterms:W3CDTF">2018-03-28T22:45:59Z</dcterms:created>
  <dcterms:modified xsi:type="dcterms:W3CDTF">2018-03-28T23:03:28Z</dcterms:modified>
</cp:coreProperties>
</file>